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7" r:id="rId5"/>
  </p:sldIdLst>
  <p:sldSz cx="13716000" cy="11430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5DBC300-1576-457C-B637-79A16FB4B4B9}" v="1" dt="2021-04-11T19:41:16.029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9" d="100"/>
          <a:sy n="69" d="100"/>
        </p:scale>
        <p:origin x="180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ela, Christopher A" userId="3744e99d-2923-4ad2-9f75-6fa40f6eef64" providerId="ADAL" clId="{D5DBC300-1576-457C-B637-79A16FB4B4B9}"/>
    <pc:docChg chg="modSld">
      <pc:chgData name="Mela, Christopher A" userId="3744e99d-2923-4ad2-9f75-6fa40f6eef64" providerId="ADAL" clId="{D5DBC300-1576-457C-B637-79A16FB4B4B9}" dt="2021-04-11T19:41:21.466" v="7" actId="20577"/>
      <pc:docMkLst>
        <pc:docMk/>
      </pc:docMkLst>
      <pc:sldChg chg="modSp mod">
        <pc:chgData name="Mela, Christopher A" userId="3744e99d-2923-4ad2-9f75-6fa40f6eef64" providerId="ADAL" clId="{D5DBC300-1576-457C-B637-79A16FB4B4B9}" dt="2021-04-11T19:41:21.466" v="7" actId="20577"/>
        <pc:sldMkLst>
          <pc:docMk/>
          <pc:sldMk cId="1461302846" sldId="257"/>
        </pc:sldMkLst>
        <pc:spChg chg="mod">
          <ac:chgData name="Mela, Christopher A" userId="3744e99d-2923-4ad2-9f75-6fa40f6eef64" providerId="ADAL" clId="{D5DBC300-1576-457C-B637-79A16FB4B4B9}" dt="2021-04-11T19:41:21.466" v="7" actId="20577"/>
          <ac:spMkLst>
            <pc:docMk/>
            <pc:sldMk cId="1461302846" sldId="257"/>
            <ac:spMk id="4" creationId="{AB19B3A9-A687-493C-988E-4F3552700921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28700" y="1870605"/>
            <a:ext cx="11658600" cy="3979333"/>
          </a:xfrm>
        </p:spPr>
        <p:txBody>
          <a:bodyPr anchor="b"/>
          <a:lstStyle>
            <a:lvl1pPr algn="ctr">
              <a:defRPr sz="9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14500" y="6003397"/>
            <a:ext cx="10287000" cy="2759603"/>
          </a:xfrm>
        </p:spPr>
        <p:txBody>
          <a:bodyPr/>
          <a:lstStyle>
            <a:lvl1pPr marL="0" indent="0" algn="ctr">
              <a:buNone/>
              <a:defRPr sz="3600"/>
            </a:lvl1pPr>
            <a:lvl2pPr marL="685800" indent="0" algn="ctr">
              <a:buNone/>
              <a:defRPr sz="3000"/>
            </a:lvl2pPr>
            <a:lvl3pPr marL="1371600" indent="0" algn="ctr">
              <a:buNone/>
              <a:defRPr sz="2700"/>
            </a:lvl3pPr>
            <a:lvl4pPr marL="2057400" indent="0" algn="ctr">
              <a:buNone/>
              <a:defRPr sz="2400"/>
            </a:lvl4pPr>
            <a:lvl5pPr marL="2743200" indent="0" algn="ctr">
              <a:buNone/>
              <a:defRPr sz="2400"/>
            </a:lvl5pPr>
            <a:lvl6pPr marL="3429000" indent="0" algn="ctr">
              <a:buNone/>
              <a:defRPr sz="2400"/>
            </a:lvl6pPr>
            <a:lvl7pPr marL="4114800" indent="0" algn="ctr">
              <a:buNone/>
              <a:defRPr sz="2400"/>
            </a:lvl7pPr>
            <a:lvl8pPr marL="4800600" indent="0" algn="ctr">
              <a:buNone/>
              <a:defRPr sz="2400"/>
            </a:lvl8pPr>
            <a:lvl9pPr marL="5486400" indent="0" algn="ctr">
              <a:buNone/>
              <a:defRPr sz="24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EA88E-0F4A-4D75-BDDD-10FD3CDC7AA0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6B30E-4B45-4AA6-9854-0701BE65EF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37597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EA88E-0F4A-4D75-BDDD-10FD3CDC7AA0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6B30E-4B45-4AA6-9854-0701BE65EF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60647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815513" y="608542"/>
            <a:ext cx="2957513" cy="968639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42976" y="608542"/>
            <a:ext cx="8701088" cy="968639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EA88E-0F4A-4D75-BDDD-10FD3CDC7AA0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6B30E-4B45-4AA6-9854-0701BE65EF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87589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EA88E-0F4A-4D75-BDDD-10FD3CDC7AA0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6B30E-4B45-4AA6-9854-0701BE65EF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22488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35832" y="2849566"/>
            <a:ext cx="11830050" cy="4754562"/>
          </a:xfrm>
        </p:spPr>
        <p:txBody>
          <a:bodyPr anchor="b"/>
          <a:lstStyle>
            <a:lvl1pPr>
              <a:defRPr sz="9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35832" y="7649107"/>
            <a:ext cx="11830050" cy="2500312"/>
          </a:xfrm>
        </p:spPr>
        <p:txBody>
          <a:bodyPr/>
          <a:lstStyle>
            <a:lvl1pPr marL="0" indent="0">
              <a:buNone/>
              <a:defRPr sz="3600">
                <a:solidFill>
                  <a:schemeClr val="tx1"/>
                </a:solidFill>
              </a:defRPr>
            </a:lvl1pPr>
            <a:lvl2pPr marL="685800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2pPr>
            <a:lvl3pPr marL="137160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3pPr>
            <a:lvl4pPr marL="20574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4pPr>
            <a:lvl5pPr marL="27432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5pPr>
            <a:lvl6pPr marL="34290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6pPr>
            <a:lvl7pPr marL="41148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7pPr>
            <a:lvl8pPr marL="48006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8pPr>
            <a:lvl9pPr marL="54864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EA88E-0F4A-4D75-BDDD-10FD3CDC7AA0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6B30E-4B45-4AA6-9854-0701BE65EF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29386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42975" y="3042708"/>
            <a:ext cx="5829300" cy="725223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43725" y="3042708"/>
            <a:ext cx="5829300" cy="725223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EA88E-0F4A-4D75-BDDD-10FD3CDC7AA0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6B30E-4B45-4AA6-9854-0701BE65EF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84703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608544"/>
            <a:ext cx="11830050" cy="220927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4763" y="2801938"/>
            <a:ext cx="5802510" cy="1373187"/>
          </a:xfrm>
        </p:spPr>
        <p:txBody>
          <a:bodyPr anchor="b"/>
          <a:lstStyle>
            <a:lvl1pPr marL="0" indent="0">
              <a:buNone/>
              <a:defRPr sz="3600" b="1"/>
            </a:lvl1pPr>
            <a:lvl2pPr marL="685800" indent="0">
              <a:buNone/>
              <a:defRPr sz="3000" b="1"/>
            </a:lvl2pPr>
            <a:lvl3pPr marL="1371600" indent="0">
              <a:buNone/>
              <a:defRPr sz="2700" b="1"/>
            </a:lvl3pPr>
            <a:lvl4pPr marL="2057400" indent="0">
              <a:buNone/>
              <a:defRPr sz="2400" b="1"/>
            </a:lvl4pPr>
            <a:lvl5pPr marL="2743200" indent="0">
              <a:buNone/>
              <a:defRPr sz="2400" b="1"/>
            </a:lvl5pPr>
            <a:lvl6pPr marL="3429000" indent="0">
              <a:buNone/>
              <a:defRPr sz="2400" b="1"/>
            </a:lvl6pPr>
            <a:lvl7pPr marL="4114800" indent="0">
              <a:buNone/>
              <a:defRPr sz="2400" b="1"/>
            </a:lvl7pPr>
            <a:lvl8pPr marL="4800600" indent="0">
              <a:buNone/>
              <a:defRPr sz="2400" b="1"/>
            </a:lvl8pPr>
            <a:lvl9pPr marL="5486400" indent="0">
              <a:buNone/>
              <a:defRPr sz="2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44763" y="4175125"/>
            <a:ext cx="5802510" cy="614098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943726" y="2801938"/>
            <a:ext cx="5831087" cy="1373187"/>
          </a:xfrm>
        </p:spPr>
        <p:txBody>
          <a:bodyPr anchor="b"/>
          <a:lstStyle>
            <a:lvl1pPr marL="0" indent="0">
              <a:buNone/>
              <a:defRPr sz="3600" b="1"/>
            </a:lvl1pPr>
            <a:lvl2pPr marL="685800" indent="0">
              <a:buNone/>
              <a:defRPr sz="3000" b="1"/>
            </a:lvl2pPr>
            <a:lvl3pPr marL="1371600" indent="0">
              <a:buNone/>
              <a:defRPr sz="2700" b="1"/>
            </a:lvl3pPr>
            <a:lvl4pPr marL="2057400" indent="0">
              <a:buNone/>
              <a:defRPr sz="2400" b="1"/>
            </a:lvl4pPr>
            <a:lvl5pPr marL="2743200" indent="0">
              <a:buNone/>
              <a:defRPr sz="2400" b="1"/>
            </a:lvl5pPr>
            <a:lvl6pPr marL="3429000" indent="0">
              <a:buNone/>
              <a:defRPr sz="2400" b="1"/>
            </a:lvl6pPr>
            <a:lvl7pPr marL="4114800" indent="0">
              <a:buNone/>
              <a:defRPr sz="2400" b="1"/>
            </a:lvl7pPr>
            <a:lvl8pPr marL="4800600" indent="0">
              <a:buNone/>
              <a:defRPr sz="2400" b="1"/>
            </a:lvl8pPr>
            <a:lvl9pPr marL="5486400" indent="0">
              <a:buNone/>
              <a:defRPr sz="2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943726" y="4175125"/>
            <a:ext cx="5831087" cy="614098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EA88E-0F4A-4D75-BDDD-10FD3CDC7AA0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6B30E-4B45-4AA6-9854-0701BE65EF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6624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EA88E-0F4A-4D75-BDDD-10FD3CDC7AA0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6B30E-4B45-4AA6-9854-0701BE65EF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7485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EA88E-0F4A-4D75-BDDD-10FD3CDC7AA0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6B30E-4B45-4AA6-9854-0701BE65EF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3516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762000"/>
            <a:ext cx="4423767" cy="2667000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831087" y="1645711"/>
            <a:ext cx="6943725" cy="8122708"/>
          </a:xfrm>
        </p:spPr>
        <p:txBody>
          <a:bodyPr/>
          <a:lstStyle>
            <a:lvl1pPr>
              <a:defRPr sz="4800"/>
            </a:lvl1pPr>
            <a:lvl2pPr>
              <a:defRPr sz="4200"/>
            </a:lvl2pPr>
            <a:lvl3pPr>
              <a:defRPr sz="3600"/>
            </a:lvl3pPr>
            <a:lvl4pPr>
              <a:defRPr sz="3000"/>
            </a:lvl4pPr>
            <a:lvl5pPr>
              <a:defRPr sz="3000"/>
            </a:lvl5pPr>
            <a:lvl6pPr>
              <a:defRPr sz="3000"/>
            </a:lvl6pPr>
            <a:lvl7pPr>
              <a:defRPr sz="3000"/>
            </a:lvl7pPr>
            <a:lvl8pPr>
              <a:defRPr sz="3000"/>
            </a:lvl8pPr>
            <a:lvl9pPr>
              <a:defRPr sz="3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4762" y="3429000"/>
            <a:ext cx="4423767" cy="6352647"/>
          </a:xfrm>
        </p:spPr>
        <p:txBody>
          <a:bodyPr/>
          <a:lstStyle>
            <a:lvl1pPr marL="0" indent="0">
              <a:buNone/>
              <a:defRPr sz="2400"/>
            </a:lvl1pPr>
            <a:lvl2pPr marL="685800" indent="0">
              <a:buNone/>
              <a:defRPr sz="2100"/>
            </a:lvl2pPr>
            <a:lvl3pPr marL="1371600" indent="0">
              <a:buNone/>
              <a:defRPr sz="1800"/>
            </a:lvl3pPr>
            <a:lvl4pPr marL="2057400" indent="0">
              <a:buNone/>
              <a:defRPr sz="1500"/>
            </a:lvl4pPr>
            <a:lvl5pPr marL="2743200" indent="0">
              <a:buNone/>
              <a:defRPr sz="1500"/>
            </a:lvl5pPr>
            <a:lvl6pPr marL="3429000" indent="0">
              <a:buNone/>
              <a:defRPr sz="1500"/>
            </a:lvl6pPr>
            <a:lvl7pPr marL="4114800" indent="0">
              <a:buNone/>
              <a:defRPr sz="1500"/>
            </a:lvl7pPr>
            <a:lvl8pPr marL="4800600" indent="0">
              <a:buNone/>
              <a:defRPr sz="1500"/>
            </a:lvl8pPr>
            <a:lvl9pPr marL="5486400" indent="0">
              <a:buNone/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EA88E-0F4A-4D75-BDDD-10FD3CDC7AA0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6B30E-4B45-4AA6-9854-0701BE65EF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55658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762000"/>
            <a:ext cx="4423767" cy="2667000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831087" y="1645711"/>
            <a:ext cx="6943725" cy="8122708"/>
          </a:xfrm>
        </p:spPr>
        <p:txBody>
          <a:bodyPr anchor="t"/>
          <a:lstStyle>
            <a:lvl1pPr marL="0" indent="0">
              <a:buNone/>
              <a:defRPr sz="4800"/>
            </a:lvl1pPr>
            <a:lvl2pPr marL="685800" indent="0">
              <a:buNone/>
              <a:defRPr sz="4200"/>
            </a:lvl2pPr>
            <a:lvl3pPr marL="1371600" indent="0">
              <a:buNone/>
              <a:defRPr sz="3600"/>
            </a:lvl3pPr>
            <a:lvl4pPr marL="2057400" indent="0">
              <a:buNone/>
              <a:defRPr sz="3000"/>
            </a:lvl4pPr>
            <a:lvl5pPr marL="2743200" indent="0">
              <a:buNone/>
              <a:defRPr sz="3000"/>
            </a:lvl5pPr>
            <a:lvl6pPr marL="3429000" indent="0">
              <a:buNone/>
              <a:defRPr sz="3000"/>
            </a:lvl6pPr>
            <a:lvl7pPr marL="4114800" indent="0">
              <a:buNone/>
              <a:defRPr sz="3000"/>
            </a:lvl7pPr>
            <a:lvl8pPr marL="4800600" indent="0">
              <a:buNone/>
              <a:defRPr sz="3000"/>
            </a:lvl8pPr>
            <a:lvl9pPr marL="5486400" indent="0">
              <a:buNone/>
              <a:defRPr sz="3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4762" y="3429000"/>
            <a:ext cx="4423767" cy="6352647"/>
          </a:xfrm>
        </p:spPr>
        <p:txBody>
          <a:bodyPr/>
          <a:lstStyle>
            <a:lvl1pPr marL="0" indent="0">
              <a:buNone/>
              <a:defRPr sz="2400"/>
            </a:lvl1pPr>
            <a:lvl2pPr marL="685800" indent="0">
              <a:buNone/>
              <a:defRPr sz="2100"/>
            </a:lvl2pPr>
            <a:lvl3pPr marL="1371600" indent="0">
              <a:buNone/>
              <a:defRPr sz="1800"/>
            </a:lvl3pPr>
            <a:lvl4pPr marL="2057400" indent="0">
              <a:buNone/>
              <a:defRPr sz="1500"/>
            </a:lvl4pPr>
            <a:lvl5pPr marL="2743200" indent="0">
              <a:buNone/>
              <a:defRPr sz="1500"/>
            </a:lvl5pPr>
            <a:lvl6pPr marL="3429000" indent="0">
              <a:buNone/>
              <a:defRPr sz="1500"/>
            </a:lvl6pPr>
            <a:lvl7pPr marL="4114800" indent="0">
              <a:buNone/>
              <a:defRPr sz="1500"/>
            </a:lvl7pPr>
            <a:lvl8pPr marL="4800600" indent="0">
              <a:buNone/>
              <a:defRPr sz="1500"/>
            </a:lvl8pPr>
            <a:lvl9pPr marL="5486400" indent="0">
              <a:buNone/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EA88E-0F4A-4D75-BDDD-10FD3CDC7AA0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6B30E-4B45-4AA6-9854-0701BE65EF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58693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42975" y="608544"/>
            <a:ext cx="11830050" cy="22092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2975" y="3042708"/>
            <a:ext cx="11830050" cy="725223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42975" y="10593919"/>
            <a:ext cx="3086100" cy="6085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6EA88E-0F4A-4D75-BDDD-10FD3CDC7AA0}" type="datetimeFigureOut">
              <a:rPr lang="en-US" smtClean="0"/>
              <a:t>4/1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543425" y="10593919"/>
            <a:ext cx="4629150" cy="6085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686925" y="10593919"/>
            <a:ext cx="3086100" cy="6085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26B30E-4B45-4AA6-9854-0701BE65EF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3275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371600" rtl="0" eaLnBrk="1" latinLnBrk="0" hangingPunct="1">
        <a:lnSpc>
          <a:spcPct val="90000"/>
        </a:lnSpc>
        <a:spcBef>
          <a:spcPct val="0"/>
        </a:spcBef>
        <a:buNone/>
        <a:defRPr sz="6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13716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4200" kern="1200">
          <a:solidFill>
            <a:schemeClr val="tx1"/>
          </a:solidFill>
          <a:latin typeface="+mn-lt"/>
          <a:ea typeface="+mn-ea"/>
          <a:cs typeface="+mn-cs"/>
        </a:defRPr>
      </a:lvl1pPr>
      <a:lvl2pPr marL="10287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7145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3pPr>
      <a:lvl4pPr marL="24003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30861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7719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44577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51435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8293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2pPr>
      <a:lvl3pPr marL="13716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20574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2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4290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41148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4864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159454FA-ABC5-4583-B48C-F8E1CA44127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57958444"/>
              </p:ext>
            </p:extLst>
          </p:nvPr>
        </p:nvGraphicFramePr>
        <p:xfrm>
          <a:off x="2286000" y="2003425"/>
          <a:ext cx="9601200" cy="8185404"/>
        </p:xfrm>
        <a:graphic>
          <a:graphicData uri="http://schemas.openxmlformats.org/drawingml/2006/table">
            <a:tbl>
              <a:tblPr firstRow="1" firstCol="1" bandRow="1"/>
              <a:tblGrid>
                <a:gridCol w="1920240">
                  <a:extLst>
                    <a:ext uri="{9D8B030D-6E8A-4147-A177-3AD203B41FA5}">
                      <a16:colId xmlns:a16="http://schemas.microsoft.com/office/drawing/2014/main" val="1780742107"/>
                    </a:ext>
                  </a:extLst>
                </a:gridCol>
                <a:gridCol w="1920240">
                  <a:extLst>
                    <a:ext uri="{9D8B030D-6E8A-4147-A177-3AD203B41FA5}">
                      <a16:colId xmlns:a16="http://schemas.microsoft.com/office/drawing/2014/main" val="566436353"/>
                    </a:ext>
                  </a:extLst>
                </a:gridCol>
                <a:gridCol w="1920240">
                  <a:extLst>
                    <a:ext uri="{9D8B030D-6E8A-4147-A177-3AD203B41FA5}">
                      <a16:colId xmlns:a16="http://schemas.microsoft.com/office/drawing/2014/main" val="2618392160"/>
                    </a:ext>
                  </a:extLst>
                </a:gridCol>
                <a:gridCol w="1920240">
                  <a:extLst>
                    <a:ext uri="{9D8B030D-6E8A-4147-A177-3AD203B41FA5}">
                      <a16:colId xmlns:a16="http://schemas.microsoft.com/office/drawing/2014/main" val="1861726222"/>
                    </a:ext>
                  </a:extLst>
                </a:gridCol>
                <a:gridCol w="1920240">
                  <a:extLst>
                    <a:ext uri="{9D8B030D-6E8A-4147-A177-3AD203B41FA5}">
                      <a16:colId xmlns:a16="http://schemas.microsoft.com/office/drawing/2014/main" val="2201473025"/>
                    </a:ext>
                  </a:extLst>
                </a:gridCol>
              </a:tblGrid>
              <a:tr h="5486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ell/Tissue Type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3302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1120775" algn="l"/>
                        </a:tabLst>
                      </a:pPr>
                      <a:r>
                        <a:rPr lang="en-US" sz="14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abeled Target in the Nuclei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iological/Pathological State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luorophore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ataset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9225553"/>
                  </a:ext>
                </a:extLst>
              </a:tr>
              <a:tr h="5486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T3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NA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Original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F568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ell Set A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3764115"/>
                  </a:ext>
                </a:extLst>
              </a:tr>
              <a:tr h="5486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T3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NAPII-Ser5P (active form of RNA polymerase II)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Original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lexa 647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ell Set B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6818673"/>
                  </a:ext>
                </a:extLst>
              </a:tr>
              <a:tr h="5486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T3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NA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iRNA Suv39h1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F568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ell Set A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6101804"/>
                  </a:ext>
                </a:extLst>
              </a:tr>
              <a:tr h="5486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T3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RNAPII-Ser5P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iRNA Suv39h1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lexa 647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ell Set B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8641492"/>
                  </a:ext>
                </a:extLst>
              </a:tr>
              <a:tr h="5486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CF10A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3K27me3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Original and treated with SAHA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lexa 647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ell Set B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9156419"/>
                  </a:ext>
                </a:extLst>
              </a:tr>
              <a:tr h="5486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CFCA1a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3K27me3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ancerous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lexa 647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ell Set B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34280987"/>
                  </a:ext>
                </a:extLst>
              </a:tr>
              <a:tr h="5486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CFCA1h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3K27me3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reated with SAHA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lexa 647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ell Set B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6062590"/>
                  </a:ext>
                </a:extLst>
              </a:tr>
              <a:tr h="5486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K2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3K4me3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Original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lexa 647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ell Set B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426501"/>
                  </a:ext>
                </a:extLst>
              </a:tr>
              <a:tr h="5486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K2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3K4me3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reated with TGF</a:t>
                      </a: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  <a:sym typeface="Symbol" panose="05050102010706020507" pitchFamily="18" charset="2"/>
                        </a:rPr>
                        <a:t>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lexa 647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ell Set B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02201152"/>
                  </a:ext>
                </a:extLst>
              </a:tr>
              <a:tr h="5486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C-3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3K9me3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Original, and treated with different drugs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lexa 647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ell Set B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50026275"/>
                  </a:ext>
                </a:extLst>
              </a:tr>
              <a:tr h="5486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ouse prostate tissue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3K9me3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ormal, low-grade and high-grade PIN and carcinoma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lexa 647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ostate Tissue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7384480"/>
                  </a:ext>
                </a:extLst>
              </a:tr>
              <a:tr h="5486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uman colon tissue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3K9me3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ormal, adenoma, high-grade dysplasia and carcinoma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lexa 647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lon Tissue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7997571"/>
                  </a:ext>
                </a:extLst>
              </a:tr>
              <a:tr h="5486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uman colon tissue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3K27me3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ormal, adenoma, high-grade dysplasia and carcinoma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Alexa 647</a:t>
                      </a:r>
                      <a:endParaRPr lang="en-US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lon Tissue</a:t>
                      </a:r>
                      <a:endParaRPr lang="en-US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999999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883055"/>
                  </a:ext>
                </a:extLst>
              </a:tr>
            </a:tbl>
          </a:graphicData>
        </a:graphic>
      </p:graphicFrame>
      <p:sp>
        <p:nvSpPr>
          <p:cNvPr id="4" name="Rectangle 3">
            <a:extLst>
              <a:ext uri="{FF2B5EF4-FFF2-40B4-BE49-F238E27FC236}">
                <a16:creationId xmlns:a16="http://schemas.microsoft.com/office/drawing/2014/main" id="{AB19B3A9-A687-493C-988E-4F3552700921}"/>
              </a:ext>
            </a:extLst>
          </p:cNvPr>
          <p:cNvSpPr/>
          <p:nvPr/>
        </p:nvSpPr>
        <p:spPr>
          <a:xfrm>
            <a:off x="2286000" y="1418650"/>
            <a:ext cx="960120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1</a:t>
            </a:r>
            <a:r>
              <a:rPr lang="en-US" sz="16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6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ll types included in our STORM datasets, along with their respective labeled targets, biological states, fluorophores and datasets.</a:t>
            </a:r>
            <a:endParaRPr lang="en-US" sz="1600" i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613028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D5096B1AD2CCF4FAB0BA4D16B864C84" ma:contentTypeVersion="8" ma:contentTypeDescription="Create a new document." ma:contentTypeScope="" ma:versionID="3e6634e1a46f01af2a4bae30cea8a8d1">
  <xsd:schema xmlns:xsd="http://www.w3.org/2001/XMLSchema" xmlns:xs="http://www.w3.org/2001/XMLSchema" xmlns:p="http://schemas.microsoft.com/office/2006/metadata/properties" xmlns:ns3="4c68db64-2c3b-44bc-a459-26fe4a080329" targetNamespace="http://schemas.microsoft.com/office/2006/metadata/properties" ma:root="true" ma:fieldsID="54f823baa49fc3dd204a54c49a4451f3" ns3:_="">
    <xsd:import namespace="4c68db64-2c3b-44bc-a459-26fe4a080329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c68db64-2c3b-44bc-a459-26fe4a08032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F6F24DA7-94AC-457F-9372-7A035058454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c68db64-2c3b-44bc-a459-26fe4a08032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3A78535C-2F53-487F-98F9-E3CFB6A44337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3.xml><?xml version="1.0" encoding="utf-8"?>
<ds:datastoreItem xmlns:ds="http://schemas.openxmlformats.org/officeDocument/2006/customXml" ds:itemID="{4718EF2C-6708-4420-A6F8-EDDEBE033824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192</Words>
  <Application>Microsoft Office PowerPoint</Application>
  <PresentationFormat>Custom</PresentationFormat>
  <Paragraphs>7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la, Christopher A</dc:creator>
  <cp:lastModifiedBy>Mela, Christopher A</cp:lastModifiedBy>
  <cp:revision>1</cp:revision>
  <dcterms:created xsi:type="dcterms:W3CDTF">2021-01-03T16:28:06Z</dcterms:created>
  <dcterms:modified xsi:type="dcterms:W3CDTF">2021-04-11T19:41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D5096B1AD2CCF4FAB0BA4D16B864C84</vt:lpwstr>
  </property>
</Properties>
</file>